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61" r:id="rId2"/>
    <p:sldId id="260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319ADA6-FD94-4623-ABDD-3DAB46062C3C}" v="2" dt="2023-08-28T10:53:42.85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121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eiji HAYASHI" userId="b57fd104-0b62-4927-945a-9fd9da4f42bb" providerId="ADAL" clId="{3319ADA6-FD94-4623-ABDD-3DAB46062C3C}"/>
    <pc:docChg chg="modSld">
      <pc:chgData name="Seiji HAYASHI" userId="b57fd104-0b62-4927-945a-9fd9da4f42bb" providerId="ADAL" clId="{3319ADA6-FD94-4623-ABDD-3DAB46062C3C}" dt="2023-08-28T10:53:46.065" v="17" actId="6549"/>
      <pc:docMkLst>
        <pc:docMk/>
      </pc:docMkLst>
      <pc:sldChg chg="modSp mod">
        <pc:chgData name="Seiji HAYASHI" userId="b57fd104-0b62-4927-945a-9fd9da4f42bb" providerId="ADAL" clId="{3319ADA6-FD94-4623-ABDD-3DAB46062C3C}" dt="2023-08-28T10:53:46.065" v="17" actId="6549"/>
        <pc:sldMkLst>
          <pc:docMk/>
          <pc:sldMk cId="1081554727" sldId="261"/>
        </pc:sldMkLst>
        <pc:spChg chg="mod">
          <ac:chgData name="Seiji HAYASHI" userId="b57fd104-0b62-4927-945a-9fd9da4f42bb" providerId="ADAL" clId="{3319ADA6-FD94-4623-ABDD-3DAB46062C3C}" dt="2023-08-28T10:53:46.065" v="17" actId="6549"/>
          <ac:spMkLst>
            <pc:docMk/>
            <pc:sldMk cId="1081554727" sldId="261"/>
            <ac:spMk id="2" creationId="{7E67404D-B683-A0DD-5DBB-264D66261535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789D59-71AE-4E2F-8E39-D7F2CCD4B84E}" type="datetimeFigureOut">
              <a:rPr kumimoji="1" lang="ja-JP" altLang="en-US" smtClean="0"/>
              <a:t>2023/8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5F1C27-8246-4F33-8DED-5C3B83BED5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8326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9C40A39-237E-436B-90F8-D9F4FF530A96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818748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AB6EE-5C96-4945-9460-ED9D900F4B90}" type="datetimeFigureOut">
              <a:rPr kumimoji="1" lang="ja-JP" altLang="en-US" smtClean="0"/>
              <a:t>2023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27210-1EA6-4701-9930-8238AB6197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9378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AB6EE-5C96-4945-9460-ED9D900F4B90}" type="datetimeFigureOut">
              <a:rPr kumimoji="1" lang="ja-JP" altLang="en-US" smtClean="0"/>
              <a:t>2023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27210-1EA6-4701-9930-8238AB6197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0756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AB6EE-5C96-4945-9460-ED9D900F4B90}" type="datetimeFigureOut">
              <a:rPr kumimoji="1" lang="ja-JP" altLang="en-US" smtClean="0"/>
              <a:t>2023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27210-1EA6-4701-9930-8238AB6197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6218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AB6EE-5C96-4945-9460-ED9D900F4B90}" type="datetimeFigureOut">
              <a:rPr kumimoji="1" lang="ja-JP" altLang="en-US" smtClean="0"/>
              <a:t>2023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27210-1EA6-4701-9930-8238AB6197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6093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AB6EE-5C96-4945-9460-ED9D900F4B90}" type="datetimeFigureOut">
              <a:rPr kumimoji="1" lang="ja-JP" altLang="en-US" smtClean="0"/>
              <a:t>2023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27210-1EA6-4701-9930-8238AB6197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8047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AB6EE-5C96-4945-9460-ED9D900F4B90}" type="datetimeFigureOut">
              <a:rPr kumimoji="1" lang="ja-JP" altLang="en-US" smtClean="0"/>
              <a:t>2023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27210-1EA6-4701-9930-8238AB6197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600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AB6EE-5C96-4945-9460-ED9D900F4B90}" type="datetimeFigureOut">
              <a:rPr kumimoji="1" lang="ja-JP" altLang="en-US" smtClean="0"/>
              <a:t>2023/8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27210-1EA6-4701-9930-8238AB6197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6894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AB6EE-5C96-4945-9460-ED9D900F4B90}" type="datetimeFigureOut">
              <a:rPr kumimoji="1" lang="ja-JP" altLang="en-US" smtClean="0"/>
              <a:t>2023/8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27210-1EA6-4701-9930-8238AB6197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180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AB6EE-5C96-4945-9460-ED9D900F4B90}" type="datetimeFigureOut">
              <a:rPr kumimoji="1" lang="ja-JP" altLang="en-US" smtClean="0"/>
              <a:t>2023/8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27210-1EA6-4701-9930-8238AB6197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9379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AB6EE-5C96-4945-9460-ED9D900F4B90}" type="datetimeFigureOut">
              <a:rPr kumimoji="1" lang="ja-JP" altLang="en-US" smtClean="0"/>
              <a:t>2023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27210-1EA6-4701-9930-8238AB6197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5621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AB6EE-5C96-4945-9460-ED9D900F4B90}" type="datetimeFigureOut">
              <a:rPr kumimoji="1" lang="ja-JP" altLang="en-US" smtClean="0"/>
              <a:t>2023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27210-1EA6-4701-9930-8238AB6197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7821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4AB6EE-5C96-4945-9460-ED9D900F4B90}" type="datetimeFigureOut">
              <a:rPr kumimoji="1" lang="ja-JP" altLang="en-US" smtClean="0"/>
              <a:t>2023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327210-1EA6-4701-9930-8238AB6197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0178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67404D-B683-A0DD-5DBB-264D662615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5"/>
            <a:ext cx="7886700" cy="4751623"/>
          </a:xfrm>
        </p:spPr>
        <p:txBody>
          <a:bodyPr>
            <a:normAutofit/>
          </a:bodyPr>
          <a:lstStyle/>
          <a:p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itle:</a:t>
            </a:r>
            <a:r>
              <a:rPr lang="ja-JP" altLang="en-US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Explaining the variation in </a:t>
            </a:r>
            <a:r>
              <a:rPr lang="en-US" altLang="ja-JP" sz="18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137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s aggregated transfer factor for wild edible plants as a case study on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Koshiabura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(</a:t>
            </a:r>
            <a:r>
              <a:rPr lang="en-US" altLang="ja-JP" sz="1800" i="1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Eleutherococcus</a:t>
            </a:r>
            <a:r>
              <a:rPr lang="en-US" altLang="ja-JP" sz="18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sz="1800" i="1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ciadophylloide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) buds</a:t>
            </a:r>
            <a:b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</a:br>
            <a:b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</a:b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Authors</a:t>
            </a:r>
            <a:r>
              <a:rPr lang="ja-JP" altLang="en-US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：</a:t>
            </a:r>
            <a:b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</a:b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eiji Hayashi, Mirai Watanabe, Masami </a:t>
            </a:r>
            <a:r>
              <a:rPr lang="en-US" altLang="ja-JP" sz="18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anao</a:t>
            </a:r>
            <a:r>
              <a:rPr lang="ja-JP" altLang="en-US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oshikawa, Momo Takada, Seiichi </a:t>
            </a:r>
            <a:r>
              <a:rPr lang="en-US" altLang="ja-JP" sz="18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akechi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i Takagi, Masaru Sakai &amp; Masanori </a:t>
            </a:r>
            <a:r>
              <a:rPr lang="en-US" altLang="ja-JP" sz="18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amaoki</a:t>
            </a:r>
            <a:br>
              <a:rPr lang="ja-JP" altLang="ja-JP" sz="1800" kern="100" dirty="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</a:b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0815547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id="{1A9892BF-86A5-4343-BD71-8CDF9477A9CA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298450" y="1343025"/>
          <a:ext cx="8493213" cy="482600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106523">
                  <a:extLst>
                    <a:ext uri="{9D8B030D-6E8A-4147-A177-3AD203B41FA5}">
                      <a16:colId xmlns:a16="http://schemas.microsoft.com/office/drawing/2014/main" val="3980531926"/>
                    </a:ext>
                  </a:extLst>
                </a:gridCol>
                <a:gridCol w="1286500">
                  <a:extLst>
                    <a:ext uri="{9D8B030D-6E8A-4147-A177-3AD203B41FA5}">
                      <a16:colId xmlns:a16="http://schemas.microsoft.com/office/drawing/2014/main" val="3470283588"/>
                    </a:ext>
                  </a:extLst>
                </a:gridCol>
                <a:gridCol w="1362148">
                  <a:extLst>
                    <a:ext uri="{9D8B030D-6E8A-4147-A177-3AD203B41FA5}">
                      <a16:colId xmlns:a16="http://schemas.microsoft.com/office/drawing/2014/main" val="1624535834"/>
                    </a:ext>
                  </a:extLst>
                </a:gridCol>
                <a:gridCol w="1270845">
                  <a:extLst>
                    <a:ext uri="{9D8B030D-6E8A-4147-A177-3AD203B41FA5}">
                      <a16:colId xmlns:a16="http://schemas.microsoft.com/office/drawing/2014/main" val="2441483144"/>
                    </a:ext>
                  </a:extLst>
                </a:gridCol>
                <a:gridCol w="1106523">
                  <a:extLst>
                    <a:ext uri="{9D8B030D-6E8A-4147-A177-3AD203B41FA5}">
                      <a16:colId xmlns:a16="http://schemas.microsoft.com/office/drawing/2014/main" val="2331983147"/>
                    </a:ext>
                  </a:extLst>
                </a:gridCol>
                <a:gridCol w="1180337">
                  <a:extLst>
                    <a:ext uri="{9D8B030D-6E8A-4147-A177-3AD203B41FA5}">
                      <a16:colId xmlns:a16="http://schemas.microsoft.com/office/drawing/2014/main" val="1012986418"/>
                    </a:ext>
                  </a:extLst>
                </a:gridCol>
                <a:gridCol w="1180337">
                  <a:extLst>
                    <a:ext uri="{9D8B030D-6E8A-4147-A177-3AD203B41FA5}">
                      <a16:colId xmlns:a16="http://schemas.microsoft.com/office/drawing/2014/main" val="237802053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ta type/ year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 of measurement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 of administrative district 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M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kumimoji="1" lang="en-US" altLang="ja-JP" sz="14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q</a:t>
                      </a:r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kg-FM)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D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.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kumimoji="1" lang="en-US" altLang="ja-JP" sz="14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q</a:t>
                      </a:r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kg-FM)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.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kumimoji="1" lang="en-US" altLang="ja-JP" sz="14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q</a:t>
                      </a:r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kg-FM)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41410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blicly available data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05392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,880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42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58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9,000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67019498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,850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37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91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3,300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818431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,190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.96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93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1,500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79770253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,540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.37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25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1,600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771012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,050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.95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97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1,600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2721081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,080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46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950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,700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1980941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,030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.94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24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,400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25361807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d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227159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-2020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00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0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,800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21432355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998BF18-2471-47D3-A998-FC303CF3A08D}"/>
              </a:ext>
            </a:extLst>
          </p:cNvPr>
          <p:cNvSpPr txBox="1"/>
          <p:nvPr/>
        </p:nvSpPr>
        <p:spPr>
          <a:xfrm>
            <a:off x="115711" y="168017"/>
            <a:ext cx="891257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able S1 Summary statistics for </a:t>
            </a:r>
            <a:r>
              <a:rPr kumimoji="1" lang="en-US" altLang="ja-JP" sz="1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37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s activity concentration in </a:t>
            </a:r>
            <a:r>
              <a:rPr kumimoji="1" lang="en-US" altLang="ja-JP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oshiabura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0" lang="en-US" altLang="ja-JP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leutherococcus</a:t>
            </a:r>
            <a:r>
              <a:rPr kumimoji="0" lang="en-US" altLang="ja-JP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iadophylloides</a:t>
            </a:r>
            <a:r>
              <a:rPr kumimoji="0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kumimoji="1" lang="en-US" altLang="ja-JP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ud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 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rom publicly available data reported by </a:t>
            </a:r>
            <a:r>
              <a:rPr kumimoji="1" lang="en-US" altLang="ja-JP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itate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Village</a:t>
            </a:r>
            <a:r>
              <a:rPr kumimoji="1" lang="en-US" altLang="ja-JP" sz="1800" b="0" i="0" u="none" strike="noStrike" kern="1200" cap="none" spc="0" normalizeH="0" baseline="3000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49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and the measurements recorded in the present study.  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9788393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</TotalTime>
  <Words>183</Words>
  <Application>Microsoft Office PowerPoint</Application>
  <PresentationFormat>画面に合わせる (4:3)</PresentationFormat>
  <Paragraphs>71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游ゴシック</vt:lpstr>
      <vt:lpstr>游明朝</vt:lpstr>
      <vt:lpstr>Arial</vt:lpstr>
      <vt:lpstr>Calibri</vt:lpstr>
      <vt:lpstr>Calibri Light</vt:lpstr>
      <vt:lpstr>Times New Roman</vt:lpstr>
      <vt:lpstr>1_Office テーマ</vt:lpstr>
      <vt:lpstr>Title: Explaining the variation in 137Cs aggregated transfer factor for wild edible plants as a case study on Koshiabura (Eleutherococcus sciadophylloides) buds  Authors： Seiji Hayashi, Mirai Watanabe, Masami Kanao Koshikawa, Momo Takada, Seiichi Takechi, Mai Takagi, Masaru Sakai &amp; Masanori Tamaoki 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誠二 林</dc:creator>
  <cp:lastModifiedBy>誠二 林</cp:lastModifiedBy>
  <cp:revision>2</cp:revision>
  <dcterms:created xsi:type="dcterms:W3CDTF">2023-07-06T11:52:38Z</dcterms:created>
  <dcterms:modified xsi:type="dcterms:W3CDTF">2023-08-28T10:53:50Z</dcterms:modified>
</cp:coreProperties>
</file>